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2192000" cy="21674138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6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73" d="100"/>
          <a:sy n="73" d="100"/>
        </p:scale>
        <p:origin x="2034" y="-2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3547135"/>
            <a:ext cx="10363200" cy="7545811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11383941"/>
            <a:ext cx="9144000" cy="5232898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7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4050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7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52912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1153947"/>
            <a:ext cx="2628900" cy="1836783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1153947"/>
            <a:ext cx="7734300" cy="1836783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7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66582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7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84988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5403489"/>
            <a:ext cx="10515600" cy="9015838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4504620"/>
            <a:ext cx="10515600" cy="4741216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7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24290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5769736"/>
            <a:ext cx="5181600" cy="1375204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5769736"/>
            <a:ext cx="5181600" cy="1375204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7/03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6489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153952"/>
            <a:ext cx="10515600" cy="418933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5313176"/>
            <a:ext cx="5157787" cy="260390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7917081"/>
            <a:ext cx="5157787" cy="1164483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5313176"/>
            <a:ext cx="5183188" cy="260390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7917081"/>
            <a:ext cx="5183188" cy="1164483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7/03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1202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7/03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6734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7/03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4192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444942"/>
            <a:ext cx="3932237" cy="505729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3120679"/>
            <a:ext cx="6172200" cy="1540268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6502241"/>
            <a:ext cx="3932237" cy="1204620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7/03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64811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444942"/>
            <a:ext cx="3932237" cy="505729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3120679"/>
            <a:ext cx="6172200" cy="1540268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6502241"/>
            <a:ext cx="3932237" cy="1204620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7/03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9451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1153952"/>
            <a:ext cx="10515600" cy="418933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5769736"/>
            <a:ext cx="10515600" cy="137520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20088720"/>
            <a:ext cx="27432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2E4568-5ACD-435D-8C4D-5A025A52F662}" type="datetimeFigureOut">
              <a:rPr lang="en-GB" smtClean="0"/>
              <a:t>27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20088720"/>
            <a:ext cx="41148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20088720"/>
            <a:ext cx="27432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6000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825581" y="3584435"/>
            <a:ext cx="4654962" cy="2834211"/>
            <a:chOff x="913679" y="2360319"/>
            <a:chExt cx="4654962" cy="2834211"/>
          </a:xfrm>
        </p:grpSpPr>
        <p:pic>
          <p:nvPicPr>
            <p:cNvPr id="102" name="Picture 2" descr="C:\Users\bsp01b\Google Drive\PhD\Results\chapter 4 proliferation\HCt116 shrna growth curve.png"/>
            <p:cNvPicPr>
              <a:picLocks noChangeAspect="1" noChangeArrowheads="1"/>
            </p:cNvPicPr>
            <p:nvPr/>
          </p:nvPicPr>
          <p:blipFill rotWithShape="1">
            <a:blip r:embed="rId2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273" r="41359" b="18999"/>
            <a:stretch/>
          </p:blipFill>
          <p:spPr bwMode="auto">
            <a:xfrm>
              <a:off x="1832935" y="2622176"/>
              <a:ext cx="2860090" cy="206215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TextBox 11"/>
            <p:cNvSpPr txBox="1"/>
            <p:nvPr/>
          </p:nvSpPr>
          <p:spPr>
            <a:xfrm>
              <a:off x="2374060" y="4684333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732850" y="4684333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015270" y="4684333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670335" y="4684333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325107" y="4684333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99485" y="3786343"/>
              <a:ext cx="7986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.0x10</a:t>
              </a:r>
              <a:r>
                <a:rPr lang="en-GB" sz="1400" b="1" baseline="300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GB" sz="1400" b="1" baseline="300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464970" y="4481872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 rot="16200000">
              <a:off x="82619" y="3586756"/>
              <a:ext cx="19698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tal number of cells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252255" y="3589419"/>
              <a:ext cx="13163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rgbClr val="96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MSO + DOX</a:t>
              </a:r>
              <a:endParaRPr lang="en-GB" sz="1400" b="1" dirty="0">
                <a:solidFill>
                  <a:srgbClr val="96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258179" y="3174709"/>
              <a:ext cx="7232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en-GB" sz="14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539210" y="4886753"/>
              <a:ext cx="117525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ime (days)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3674710" y="3985480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smtClean="0"/>
                <a:t>*</a:t>
              </a:r>
              <a:endParaRPr lang="es-ES" sz="1200" dirty="0"/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3996569" y="3867966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smtClean="0"/>
                <a:t>*</a:t>
              </a:r>
              <a:endParaRPr lang="es-ES" sz="1200" dirty="0"/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3388976" y="4006466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smtClean="0"/>
                <a:t>*</a:t>
              </a:r>
              <a:endParaRPr lang="es-ES" sz="1200" dirty="0"/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1099485" y="3431333"/>
              <a:ext cx="7986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.0x10</a:t>
              </a:r>
              <a:r>
                <a:rPr lang="en-GB" sz="1400" b="1" baseline="300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GB" sz="1400" b="1" baseline="300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1099485" y="3080452"/>
              <a:ext cx="7986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.0x10</a:t>
              </a:r>
              <a:r>
                <a:rPr lang="en-GB" sz="1400" b="1" baseline="300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GB" sz="1400" b="1" baseline="300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1099485" y="4126862"/>
              <a:ext cx="7986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.0x10</a:t>
              </a:r>
              <a:r>
                <a:rPr lang="en-GB" sz="1400" b="1" baseline="300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GB" sz="1400" b="1" baseline="300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1099485" y="2718078"/>
              <a:ext cx="7986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0x10</a:t>
              </a:r>
              <a:r>
                <a:rPr lang="en-GB" sz="1400" b="1" baseline="300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en-GB" sz="1400" b="1" baseline="300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2688490" y="2360319"/>
              <a:ext cx="208717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CT116 </a:t>
              </a:r>
              <a:r>
                <a:rPr lang="en-GB" sz="1400" b="1" i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EX19</a:t>
              </a:r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shRNA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2" name="Group 21"/>
          <p:cNvGrpSpPr/>
          <p:nvPr/>
        </p:nvGrpSpPr>
        <p:grpSpPr>
          <a:xfrm>
            <a:off x="7444071" y="3684185"/>
            <a:ext cx="872733" cy="2960323"/>
            <a:chOff x="5717012" y="6135317"/>
            <a:chExt cx="872733" cy="2960323"/>
          </a:xfrm>
        </p:grpSpPr>
        <p:pic>
          <p:nvPicPr>
            <p:cNvPr id="26" name="Picture 25"/>
            <p:cNvPicPr>
              <a:picLocks noChangeAspect="1"/>
            </p:cNvPicPr>
            <p:nvPr/>
          </p:nvPicPr>
          <p:blipFill rotWithShape="1">
            <a:blip r:embed="rId3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612" t="8270" r="46357" b="41689"/>
            <a:stretch/>
          </p:blipFill>
          <p:spPr>
            <a:xfrm>
              <a:off x="6141264" y="6529404"/>
              <a:ext cx="448481" cy="1883676"/>
            </a:xfrm>
            <a:prstGeom prst="rect">
              <a:avLst/>
            </a:prstGeom>
          </p:spPr>
        </p:pic>
        <p:sp>
          <p:nvSpPr>
            <p:cNvPr id="27" name="TextBox 26"/>
            <p:cNvSpPr txBox="1"/>
            <p:nvPr/>
          </p:nvSpPr>
          <p:spPr>
            <a:xfrm>
              <a:off x="5906016" y="7093177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5918912" y="8186670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5906016" y="6517873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908312" y="7634105"/>
              <a:ext cx="2794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 rot="16200000">
              <a:off x="4609979" y="7242350"/>
              <a:ext cx="25218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rmalized fold expression</a:t>
              </a:r>
              <a:endParaRPr lang="en-GB" sz="14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 rot="17400000">
              <a:off x="5707833" y="8536031"/>
              <a:ext cx="81144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 Dox</a:t>
              </a:r>
              <a:endParaRPr lang="en-GB" sz="14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 rot="17400000">
              <a:off x="5994286" y="8491881"/>
              <a:ext cx="6767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solidFill>
                    <a:srgbClr val="96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Dox</a:t>
              </a:r>
              <a:endParaRPr lang="en-GB" sz="1400" b="1" dirty="0">
                <a:solidFill>
                  <a:srgbClr val="96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528514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26</TotalTime>
  <Words>40</Words>
  <Application>Microsoft Office PowerPoint</Application>
  <PresentationFormat>Custom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Pryfysgol Bangor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msay McFarlane</dc:creator>
  <cp:lastModifiedBy>Ramsay McFarlane</cp:lastModifiedBy>
  <cp:revision>35</cp:revision>
  <cp:lastPrinted>2016-08-11T12:23:47Z</cp:lastPrinted>
  <dcterms:created xsi:type="dcterms:W3CDTF">2016-08-11T08:24:58Z</dcterms:created>
  <dcterms:modified xsi:type="dcterms:W3CDTF">2017-03-27T12:49:47Z</dcterms:modified>
</cp:coreProperties>
</file>